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006" autoAdjust="0"/>
    <p:restoredTop sz="94660"/>
  </p:normalViewPr>
  <p:slideViewPr>
    <p:cSldViewPr snapToGrid="0">
      <p:cViewPr varScale="1">
        <p:scale>
          <a:sx n="79" d="100"/>
          <a:sy n="79" d="100"/>
        </p:scale>
        <p:origin x="80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C970DE3-F048-46DE-8678-19456351B3E3}" type="datetimeFigureOut">
              <a:rPr lang="ko-KR" altLang="en-US" smtClean="0"/>
              <a:t>2024-09-05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D71B76D-D05E-43A1-A9E6-9B27B92F01A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840801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D71B76D-D05E-43A1-A9E6-9B27B92F01A7}" type="slidenum">
              <a:rPr lang="ko-KR" altLang="en-US" smtClean="0"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902676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5C745CE-F57C-48CC-7CBF-7DEA712EAA9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430D8EA4-08EB-BD1F-04B1-3E4CE394ADC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F98DBFB8-F944-D798-C492-C4D0EACB12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24F074-2926-45A3-A497-5877C86E0B6A}" type="datetimeFigureOut">
              <a:rPr lang="ko-KR" altLang="en-US" smtClean="0"/>
              <a:t>2024-09-0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BC7015F-A397-0F96-4D81-957247652E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169D7F2-6858-68EC-9AB4-AC2651C6FA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36446-E136-45D8-959E-1887355A21D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769551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D6A2930-C1E9-817E-8A0C-59E94D3382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15619566-2D87-3568-D175-8DCA7ADA80E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92024DE-A05D-58E0-E8F1-AD78E63089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24F074-2926-45A3-A497-5877C86E0B6A}" type="datetimeFigureOut">
              <a:rPr lang="ko-KR" altLang="en-US" smtClean="0"/>
              <a:t>2024-09-0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BB9305BC-91FC-61BA-7C82-FD72BCF0BC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B2569D4-6D7D-97C2-8F08-8AC9886FDC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36446-E136-45D8-959E-1887355A21D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730744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57D80613-52D6-A521-1FA3-A0686E5E04C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35DBF6FD-36BD-6DC8-1D55-7A71AB88DFF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24EFEA3-632C-9749-5468-BA82C8554C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24F074-2926-45A3-A497-5877C86E0B6A}" type="datetimeFigureOut">
              <a:rPr lang="ko-KR" altLang="en-US" smtClean="0"/>
              <a:t>2024-09-0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BA048ADD-9151-4DA4-0B2A-ED52C63FFA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97615A8-2C2E-4254-1D31-C858FA4745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36446-E136-45D8-959E-1887355A21D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829342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7FDD9DB-8628-7FBD-9D0E-37E72559FE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8EBE38A8-BC3F-E875-3B9E-77C549FA63D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FBD0EBE7-2C2D-4784-529D-177A67BA88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24F074-2926-45A3-A497-5877C86E0B6A}" type="datetimeFigureOut">
              <a:rPr lang="ko-KR" altLang="en-US" smtClean="0"/>
              <a:t>2024-09-0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D8B74FE-9A67-4014-AB23-C36D59FC6A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C8D48DC-9366-03F2-F819-03590E09AC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36446-E136-45D8-959E-1887355A21D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745181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58A566F-C014-5E6C-FBE6-97B988EE89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A151138D-7C24-0300-6BA4-B59297D162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1B42F05C-680A-27E6-C200-5D896611EF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24F074-2926-45A3-A497-5877C86E0B6A}" type="datetimeFigureOut">
              <a:rPr lang="ko-KR" altLang="en-US" smtClean="0"/>
              <a:t>2024-09-0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B17841CE-89C6-384C-9933-EFF70154E2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20D8C86-1445-A2B9-554B-98BE5A410A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36446-E136-45D8-959E-1887355A21D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7982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C49EC83-0822-8C3F-4E89-CAC8461516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511F2257-CB27-9BDD-2F3C-27DF72DC1A3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DBA17E85-D75C-943D-CB47-E6B82A0FACF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508DD8A3-B847-8A89-A197-0512736AE7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24F074-2926-45A3-A497-5877C86E0B6A}" type="datetimeFigureOut">
              <a:rPr lang="ko-KR" altLang="en-US" smtClean="0"/>
              <a:t>2024-09-05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C33DCC9F-28D1-1E5F-E0B2-45449633BB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1C4DFFCD-B9D8-CA3E-C839-3220F1AF34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36446-E136-45D8-959E-1887355A21D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419691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7CFE84B-7A99-0F16-B1D4-DA58E7E125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AE338258-E9DB-A228-BA46-39B5C94C7D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A412E702-5C35-0972-4969-9F8EC550411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AF9FFD41-3E76-A655-2A2B-BED4CDF712B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E2528428-E4E9-2C58-295C-D11D871DF8B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30CC1626-B5D9-0C20-4526-75D9CC0134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24F074-2926-45A3-A497-5877C86E0B6A}" type="datetimeFigureOut">
              <a:rPr lang="ko-KR" altLang="en-US" smtClean="0"/>
              <a:t>2024-09-05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C929651C-DEAE-F07A-37F1-22E62D38EA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DB976FCA-279A-C666-50AB-1BC6B04F6A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36446-E136-45D8-959E-1887355A21D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705474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225CE4A-2786-E0D7-BD37-BA0E41F40A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82EF9616-29B8-7A38-CC78-4BA46105DD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24F074-2926-45A3-A497-5877C86E0B6A}" type="datetimeFigureOut">
              <a:rPr lang="ko-KR" altLang="en-US" smtClean="0"/>
              <a:t>2024-09-05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BD6725B4-4361-B44A-4FAD-083F4D3F93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A7E80733-C021-F345-9703-F26BD80C74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36446-E136-45D8-959E-1887355A21D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508038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67E55140-7746-948D-6C10-2BA3406666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24F074-2926-45A3-A497-5877C86E0B6A}" type="datetimeFigureOut">
              <a:rPr lang="ko-KR" altLang="en-US" smtClean="0"/>
              <a:t>2024-09-05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76439B19-18E8-B4A4-F32A-F78C3AD0C9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BAFB96B5-EA34-BFCC-DFFD-E5894220D1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36446-E136-45D8-959E-1887355A21D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154438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A14D6E4-B327-0E7E-9109-5F395FEEE0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16A4B3AF-9AFE-D4EA-C467-11713C31512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26F0CD13-85C2-7420-8468-7AF78A7A48B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C0D8ACBA-A66B-CA74-26C4-47F5A41CA9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24F074-2926-45A3-A497-5877C86E0B6A}" type="datetimeFigureOut">
              <a:rPr lang="ko-KR" altLang="en-US" smtClean="0"/>
              <a:t>2024-09-05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E6E20AB7-0BE5-ABD3-6966-E60090F9B9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4CD67A83-A4AD-AE91-3F15-B2E23DDDB0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36446-E136-45D8-959E-1887355A21D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78741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6763AC0-1C01-7EB1-7A2B-D0A6995785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A0550AF9-A3F8-2D75-51DF-0B2A9241116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B5428B53-59CF-A626-2FD7-25688563A67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379D56C6-A1AA-7CFF-9E56-CBC4AD64B6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24F074-2926-45A3-A497-5877C86E0B6A}" type="datetimeFigureOut">
              <a:rPr lang="ko-KR" altLang="en-US" smtClean="0"/>
              <a:t>2024-09-05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99F4E82A-94B5-CE05-6C5C-77BE4D9841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90298005-CC4B-7510-6FE0-EE0C049F7B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36446-E136-45D8-959E-1887355A21D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723390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502BF30E-4D7E-9EE8-C1FD-AB0D2DEFCC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121BE758-A123-1573-2299-EB49C270FB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4F22F58-4745-5A5B-2866-E991C8E6E49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24F074-2926-45A3-A497-5877C86E0B6A}" type="datetimeFigureOut">
              <a:rPr lang="ko-KR" altLang="en-US" smtClean="0"/>
              <a:t>2024-09-0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43B4216-0691-C64D-67E8-FC1436B163B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6618832-2597-0006-8D77-D501DAE047D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636446-E136-45D8-959E-1887355A21D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785353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>
            <a:extLst>
              <a:ext uri="{FF2B5EF4-FFF2-40B4-BE49-F238E27FC236}">
                <a16:creationId xmlns:a16="http://schemas.microsoft.com/office/drawing/2014/main" id="{DAE2AD6B-13B9-6C38-0C75-7D64B2D7E35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21" r="333" b="383"/>
          <a:stretch/>
        </p:blipFill>
        <p:spPr>
          <a:xfrm>
            <a:off x="604045" y="500990"/>
            <a:ext cx="7660951" cy="571695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31514B8B-E9DF-55E3-0137-310C43BD7059}"/>
              </a:ext>
            </a:extLst>
          </p:cNvPr>
          <p:cNvSpPr txBox="1"/>
          <p:nvPr/>
        </p:nvSpPr>
        <p:spPr>
          <a:xfrm>
            <a:off x="525042" y="76691"/>
            <a:ext cx="35927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0" lang="en-US" altLang="ko-KR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ENC-</a:t>
            </a:r>
            <a:r>
              <a:rPr kumimoji="0" lang="en-US" altLang="ko-KR" sz="1800" b="1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L1</a:t>
            </a:r>
            <a:r>
              <a:rPr kumimoji="0" lang="en-US" altLang="ko-KR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-VP8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Figure 3c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0" name="표 9">
            <a:extLst>
              <a:ext uri="{FF2B5EF4-FFF2-40B4-BE49-F238E27FC236}">
                <a16:creationId xmlns:a16="http://schemas.microsoft.com/office/drawing/2014/main" id="{85121FAA-FD1A-82B1-2E3E-EB1D27D7903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35608076"/>
              </p:ext>
            </p:extLst>
          </p:nvPr>
        </p:nvGraphicFramePr>
        <p:xfrm>
          <a:off x="8451881" y="500990"/>
          <a:ext cx="3384000" cy="1097280"/>
        </p:xfrm>
        <a:graphic>
          <a:graphicData uri="http://schemas.openxmlformats.org/drawingml/2006/table">
            <a:tbl>
              <a:tblPr/>
              <a:tblGrid>
                <a:gridCol w="2268000">
                  <a:extLst>
                    <a:ext uri="{9D8B030D-6E8A-4147-A177-3AD203B41FA5}">
                      <a16:colId xmlns:a16="http://schemas.microsoft.com/office/drawing/2014/main" val="3153795904"/>
                    </a:ext>
                  </a:extLst>
                </a:gridCol>
                <a:gridCol w="1116000">
                  <a:extLst>
                    <a:ext uri="{9D8B030D-6E8A-4147-A177-3AD203B41FA5}">
                      <a16:colId xmlns:a16="http://schemas.microsoft.com/office/drawing/2014/main" val="146406021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base"/>
                      <a:endParaRPr lang="en-US" sz="1200" b="0" i="0" dirty="0">
                        <a:solidFill>
                          <a:schemeClr val="tx1"/>
                        </a:solidFill>
                        <a:effectLst/>
                        <a:highlight>
                          <a:srgbClr val="F2F2F2"/>
                        </a:highlight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12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NC-</a:t>
                      </a:r>
                      <a:r>
                        <a:rPr kumimoji="0" lang="en-US" altLang="ko-KR" sz="12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L1</a:t>
                      </a:r>
                      <a:r>
                        <a:rPr kumimoji="0" lang="en-US" altLang="ko-KR" sz="12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VP8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8209678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highlight>
                            <a:srgbClr val="F2F2F2"/>
                          </a:highlight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 Z-Average (nm)</a:t>
                      </a:r>
                      <a:r>
                        <a:rPr lang="en-US" sz="1200" b="0" i="0" dirty="0">
                          <a:solidFill>
                            <a:schemeClr val="tx1"/>
                          </a:solidFill>
                          <a:effectLst/>
                          <a:highlight>
                            <a:srgbClr val="F2F2F2"/>
                          </a:highlight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​, St Dev (d.nm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8.08, 0.3363</a:t>
                      </a:r>
                      <a:endParaRPr lang="en-US" sz="1200" b="0" i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7257969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highlight>
                            <a:srgbClr val="F2F2F2"/>
                          </a:highlight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 Polydispersity Index (PI)</a:t>
                      </a:r>
                      <a:r>
                        <a:rPr lang="en-US" sz="1200" b="0" i="0" dirty="0">
                          <a:solidFill>
                            <a:schemeClr val="tx1"/>
                          </a:solidFill>
                          <a:effectLst/>
                          <a:highlight>
                            <a:srgbClr val="F2F2F2"/>
                          </a:highlight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​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207</a:t>
                      </a:r>
                      <a:endParaRPr lang="en-US" sz="1200" b="0" i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506379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highlight>
                            <a:srgbClr val="F2F2F2"/>
                          </a:highlight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 Peak One Area by Intensity  (%)</a:t>
                      </a:r>
                      <a:r>
                        <a:rPr lang="en-US" sz="1200" b="0" i="0" dirty="0">
                          <a:solidFill>
                            <a:schemeClr val="tx1"/>
                          </a:solidFill>
                          <a:effectLst/>
                          <a:highlight>
                            <a:srgbClr val="F2F2F2"/>
                          </a:highlight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​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99.72</a:t>
                      </a:r>
                      <a:endParaRPr lang="en-US" sz="1200" b="0" i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1653459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795496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0A1EA351-452A-6FF7-AFC5-810F94A82A7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605" t="-321" r="357" b="317"/>
          <a:stretch/>
        </p:blipFill>
        <p:spPr>
          <a:xfrm>
            <a:off x="632367" y="553551"/>
            <a:ext cx="7538239" cy="5720688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6" name="표 5">
            <a:extLst>
              <a:ext uri="{FF2B5EF4-FFF2-40B4-BE49-F238E27FC236}">
                <a16:creationId xmlns:a16="http://schemas.microsoft.com/office/drawing/2014/main" id="{6D6D7579-2190-44DD-F08A-26F8DE29F70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88282698"/>
              </p:ext>
            </p:extLst>
          </p:nvPr>
        </p:nvGraphicFramePr>
        <p:xfrm>
          <a:off x="8428283" y="553551"/>
          <a:ext cx="3384000" cy="1097280"/>
        </p:xfrm>
        <a:graphic>
          <a:graphicData uri="http://schemas.openxmlformats.org/drawingml/2006/table">
            <a:tbl>
              <a:tblPr/>
              <a:tblGrid>
                <a:gridCol w="2268000">
                  <a:extLst>
                    <a:ext uri="{9D8B030D-6E8A-4147-A177-3AD203B41FA5}">
                      <a16:colId xmlns:a16="http://schemas.microsoft.com/office/drawing/2014/main" val="3153795904"/>
                    </a:ext>
                  </a:extLst>
                </a:gridCol>
                <a:gridCol w="1116000">
                  <a:extLst>
                    <a:ext uri="{9D8B030D-6E8A-4147-A177-3AD203B41FA5}">
                      <a16:colId xmlns:a16="http://schemas.microsoft.com/office/drawing/2014/main" val="381095791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base"/>
                      <a:endParaRPr lang="en-US" sz="1200" b="0" i="0" dirty="0">
                        <a:solidFill>
                          <a:schemeClr val="tx1"/>
                        </a:solidFill>
                        <a:effectLst/>
                        <a:highlight>
                          <a:srgbClr val="F2F2F2"/>
                        </a:highlight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12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NC-</a:t>
                      </a:r>
                      <a:r>
                        <a:rPr kumimoji="0" lang="en-US" altLang="ko-KR" sz="12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L2</a:t>
                      </a:r>
                      <a:r>
                        <a:rPr kumimoji="0" lang="en-US" altLang="ko-KR" sz="12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VP8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8209678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highlight>
                            <a:srgbClr val="F2F2F2"/>
                          </a:highlight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 Z-Average (nm)</a:t>
                      </a:r>
                      <a:r>
                        <a:rPr lang="en-US" sz="1200" b="0" i="0" dirty="0">
                          <a:solidFill>
                            <a:schemeClr val="tx1"/>
                          </a:solidFill>
                          <a:effectLst/>
                          <a:highlight>
                            <a:srgbClr val="F2F2F2"/>
                          </a:highlight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​, St Dev (d.nm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1200" b="0" i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1.07, 0.3504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7257969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highlight>
                            <a:srgbClr val="F2F2F2"/>
                          </a:highlight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 Polydispersity Index (PI)</a:t>
                      </a:r>
                      <a:r>
                        <a:rPr lang="en-US" sz="1200" b="0" i="0" dirty="0">
                          <a:solidFill>
                            <a:schemeClr val="tx1"/>
                          </a:solidFill>
                          <a:effectLst/>
                          <a:highlight>
                            <a:srgbClr val="F2F2F2"/>
                          </a:highlight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​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1200" b="0" i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222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506379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highlight>
                            <a:srgbClr val="F2F2F2"/>
                          </a:highlight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 Peak One Area by Intensity  (%)</a:t>
                      </a:r>
                      <a:r>
                        <a:rPr lang="en-US" sz="1200" b="0" i="0" dirty="0">
                          <a:solidFill>
                            <a:schemeClr val="tx1"/>
                          </a:solidFill>
                          <a:effectLst/>
                          <a:highlight>
                            <a:srgbClr val="F2F2F2"/>
                          </a:highlight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​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1200" b="0" i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99.14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16534597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8267C5D6-ABE8-2146-DE92-9CC2D1EB76C0}"/>
              </a:ext>
            </a:extLst>
          </p:cNvPr>
          <p:cNvSpPr txBox="1"/>
          <p:nvPr/>
        </p:nvSpPr>
        <p:spPr>
          <a:xfrm>
            <a:off x="525042" y="76691"/>
            <a:ext cx="35927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0" lang="en-US" altLang="ko-KR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ENC-</a:t>
            </a:r>
            <a:r>
              <a:rPr kumimoji="0" lang="en-US" altLang="ko-KR" sz="1800" b="1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L2</a:t>
            </a:r>
            <a:r>
              <a:rPr kumimoji="0" lang="en-US" altLang="ko-KR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-VP8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Figure 3c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7048127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텍스트, 스크린샷, 도표, 그래프이(가) 표시된 사진&#10;&#10;자동 생성된 설명">
            <a:extLst>
              <a:ext uri="{FF2B5EF4-FFF2-40B4-BE49-F238E27FC236}">
                <a16:creationId xmlns:a16="http://schemas.microsoft.com/office/drawing/2014/main" id="{E9EC3CEF-38B5-330D-6C37-C2B5E5602F9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44" t="174" r="122" b="288"/>
          <a:stretch/>
        </p:blipFill>
        <p:spPr bwMode="auto">
          <a:xfrm>
            <a:off x="590393" y="507143"/>
            <a:ext cx="7226251" cy="588185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5" name="표 4">
            <a:extLst>
              <a:ext uri="{FF2B5EF4-FFF2-40B4-BE49-F238E27FC236}">
                <a16:creationId xmlns:a16="http://schemas.microsoft.com/office/drawing/2014/main" id="{F19A1EAD-7971-C7F1-DA3B-1DE5369CBA7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6036203"/>
              </p:ext>
            </p:extLst>
          </p:nvPr>
        </p:nvGraphicFramePr>
        <p:xfrm>
          <a:off x="8112550" y="507143"/>
          <a:ext cx="3402990" cy="1097280"/>
        </p:xfrm>
        <a:graphic>
          <a:graphicData uri="http://schemas.openxmlformats.org/drawingml/2006/table">
            <a:tbl>
              <a:tblPr/>
              <a:tblGrid>
                <a:gridCol w="2296933">
                  <a:extLst>
                    <a:ext uri="{9D8B030D-6E8A-4147-A177-3AD203B41FA5}">
                      <a16:colId xmlns:a16="http://schemas.microsoft.com/office/drawing/2014/main" val="3153795904"/>
                    </a:ext>
                  </a:extLst>
                </a:gridCol>
                <a:gridCol w="1106057">
                  <a:extLst>
                    <a:ext uri="{9D8B030D-6E8A-4147-A177-3AD203B41FA5}">
                      <a16:colId xmlns:a16="http://schemas.microsoft.com/office/drawing/2014/main" val="146406021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base"/>
                      <a:endParaRPr lang="en-US" sz="1200" b="0" i="0" dirty="0">
                        <a:solidFill>
                          <a:schemeClr val="tx1"/>
                        </a:solidFill>
                        <a:effectLst/>
                        <a:highlight>
                          <a:srgbClr val="F2F2F2"/>
                        </a:highlight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12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NC-</a:t>
                      </a:r>
                      <a:r>
                        <a:rPr kumimoji="0" lang="en-US" altLang="ko-KR" sz="12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2</a:t>
                      </a:r>
                      <a:r>
                        <a:rPr kumimoji="0" lang="en-US" altLang="ko-KR" sz="12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VP8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7257969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highlight>
                            <a:srgbClr val="F2F2F2"/>
                          </a:highlight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 Z-Average (nm)</a:t>
                      </a:r>
                      <a:r>
                        <a:rPr lang="en-US" sz="1200" b="0" i="0" dirty="0">
                          <a:solidFill>
                            <a:schemeClr val="tx1"/>
                          </a:solidFill>
                          <a:effectLst/>
                          <a:highlight>
                            <a:srgbClr val="F2F2F2"/>
                          </a:highlight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​, St Dev (d.nm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9.17, 0.8082</a:t>
                      </a:r>
                      <a:endParaRPr lang="en-US" sz="1200" b="0" i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0276565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highlight>
                            <a:srgbClr val="F2F2F2"/>
                          </a:highlight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 Polydispersity Index (PI)</a:t>
                      </a:r>
                      <a:r>
                        <a:rPr lang="en-US" sz="1200" b="0" i="0" dirty="0">
                          <a:solidFill>
                            <a:schemeClr val="tx1"/>
                          </a:solidFill>
                          <a:effectLst/>
                          <a:highlight>
                            <a:srgbClr val="F2F2F2"/>
                          </a:highlight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​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219</a:t>
                      </a:r>
                      <a:endParaRPr lang="en-US" sz="1200" b="0" i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506379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highlight>
                            <a:srgbClr val="F2F2F2"/>
                          </a:highlight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 Peak One Area by Intensity  (%)</a:t>
                      </a:r>
                      <a:r>
                        <a:rPr lang="en-US" sz="1200" b="0" i="0" dirty="0">
                          <a:solidFill>
                            <a:schemeClr val="tx1"/>
                          </a:solidFill>
                          <a:effectLst/>
                          <a:highlight>
                            <a:srgbClr val="F2F2F2"/>
                          </a:highlight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​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0</a:t>
                      </a:r>
                      <a:endParaRPr lang="en-US" sz="1200" b="0" i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16534597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5837C379-BE5E-9BF3-BDE1-EE8E146747EA}"/>
              </a:ext>
            </a:extLst>
          </p:cNvPr>
          <p:cNvSpPr txBox="1"/>
          <p:nvPr/>
        </p:nvSpPr>
        <p:spPr>
          <a:xfrm>
            <a:off x="525042" y="76691"/>
            <a:ext cx="35927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0" lang="en-US" altLang="ko-KR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ENC-</a:t>
            </a:r>
            <a:r>
              <a:rPr lang="en-US" altLang="ko-KR" b="1" dirty="0">
                <a:solidFill>
                  <a:srgbClr val="FF0000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P2</a:t>
            </a:r>
            <a:r>
              <a:rPr kumimoji="0" lang="en-US" altLang="ko-KR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-VP8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Figure 4c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768560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121</Words>
  <Application>Microsoft Office PowerPoint</Application>
  <PresentationFormat>Widescreen</PresentationFormat>
  <Paragraphs>25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맑은 고딕</vt:lpstr>
      <vt:lpstr>Arial</vt:lpstr>
      <vt:lpstr>Times New Roman</vt:lpstr>
      <vt:lpstr>Office 테마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yungyo jung</dc:creator>
  <cp:lastModifiedBy>MDPI</cp:lastModifiedBy>
  <cp:revision>5</cp:revision>
  <dcterms:created xsi:type="dcterms:W3CDTF">2024-08-27T12:04:36Z</dcterms:created>
  <dcterms:modified xsi:type="dcterms:W3CDTF">2024-09-05T11:20:35Z</dcterms:modified>
</cp:coreProperties>
</file>